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594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117F4-DD75-4116-843E-102D45AFEA14}" type="datetimeFigureOut">
              <a:rPr lang="en-US" smtClean="0"/>
              <a:pPr/>
              <a:t>5/1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92641-7201-4870-8381-694E42297D5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lign3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14400" y="609600"/>
            <a:ext cx="7353300" cy="3790950"/>
          </a:xfrm>
          <a:prstGeom prst="rect">
            <a:avLst/>
          </a:prstGeom>
        </p:spPr>
      </p:pic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914400" y="4648200"/>
            <a:ext cx="7391400" cy="1477963"/>
          </a:xfrm>
        </p:spPr>
        <p:txBody>
          <a:bodyPr>
            <a:normAutofit/>
          </a:bodyPr>
          <a:lstStyle/>
          <a:p>
            <a:pPr>
              <a:buNone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	Supplemental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-Genome alignment of TX16 and Aus0004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X16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NA sequenc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in 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orwar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orientation, i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referenc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NA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equenc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o which Aus0004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aligned and compared. Mauve alignment of TX16 and Aus0004 showed 5 locally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ollinea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lock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(LC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. LCB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locate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under the middle line of Aus0004 represent 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nversion)of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 TX16 DNA sequence. White space within an LCB indicate the presence of strain-specific sequence whereas the colored area represent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omologous DNA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equenc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THSC-Housto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gallowaypena</dc:creator>
  <cp:lastModifiedBy>jgallowaypena</cp:lastModifiedBy>
  <cp:revision>3</cp:revision>
  <dcterms:created xsi:type="dcterms:W3CDTF">2012-05-09T22:00:18Z</dcterms:created>
  <dcterms:modified xsi:type="dcterms:W3CDTF">2012-05-16T18:59:45Z</dcterms:modified>
</cp:coreProperties>
</file>